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福島 亜梨花" initials="福島" lastIdx="1" clrIdx="0">
    <p:extLst>
      <p:ext uri="{19B8F6BF-5375-455C-9EA6-DF929625EA0E}">
        <p15:presenceInfo xmlns:p15="http://schemas.microsoft.com/office/powerpoint/2012/main" userId="6c2b8130dcc68e5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77" autoAdjust="0"/>
    <p:restoredTop sz="90867" autoAdjust="0"/>
  </p:normalViewPr>
  <p:slideViewPr>
    <p:cSldViewPr snapToGrid="0">
      <p:cViewPr varScale="1">
        <p:scale>
          <a:sx n="104" d="100"/>
          <a:sy n="104" d="100"/>
        </p:scale>
        <p:origin x="70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6(a)'!$J$1</c:f>
              <c:strCache>
                <c:ptCount val="1"/>
                <c:pt idx="0">
                  <c:v>maSigPro+MLR</c:v>
                </c:pt>
              </c:strCache>
            </c:strRef>
          </c:tx>
          <c:spPr>
            <a:solidFill>
              <a:schemeClr val="bg1"/>
            </a:solidFill>
            <a:ln w="317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317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615-493B-97E0-56C452BE299E}"/>
              </c:ext>
            </c:extLst>
          </c:dPt>
          <c:errBars>
            <c:errBarType val="both"/>
            <c:errValType val="cust"/>
            <c:noEndCap val="0"/>
            <c:plus>
              <c:numRef>
                <c:f>'Fig6(a)'!$N$2:$N$6</c:f>
                <c:numCache>
                  <c:formatCode>General</c:formatCode>
                  <c:ptCount val="5"/>
                  <c:pt idx="0">
                    <c:v>15</c:v>
                  </c:pt>
                  <c:pt idx="1">
                    <c:v>1.2280701754385959</c:v>
                  </c:pt>
                  <c:pt idx="2">
                    <c:v>8.0701754385964932</c:v>
                  </c:pt>
                  <c:pt idx="3">
                    <c:v>2.9824561403508696</c:v>
                  </c:pt>
                  <c:pt idx="4">
                    <c:v>11.6666666666667</c:v>
                  </c:pt>
                </c:numCache>
              </c:numRef>
            </c:plus>
            <c:minus>
              <c:numRef>
                <c:f>'Fig6(a)'!$R$2:$R$6</c:f>
                <c:numCache>
                  <c:formatCode>General</c:formatCode>
                  <c:ptCount val="5"/>
                  <c:pt idx="0">
                    <c:v>19.473684210526301</c:v>
                  </c:pt>
                  <c:pt idx="1">
                    <c:v>0.61403508771930149</c:v>
                  </c:pt>
                  <c:pt idx="2">
                    <c:v>9.2982456140351033</c:v>
                  </c:pt>
                  <c:pt idx="3">
                    <c:v>4.1228070175438276</c:v>
                  </c:pt>
                  <c:pt idx="4">
                    <c:v>7.5438596491227941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6(a)'!$I$2:$I$6</c:f>
              <c:strCache>
                <c:ptCount val="5"/>
                <c:pt idx="0">
                  <c:v>CP1</c:v>
                </c:pt>
                <c:pt idx="1">
                  <c:v>CP2</c:v>
                </c:pt>
                <c:pt idx="2">
                  <c:v>CP3</c:v>
                </c:pt>
                <c:pt idx="3">
                  <c:v>CP4</c:v>
                </c:pt>
                <c:pt idx="4">
                  <c:v>CP5</c:v>
                </c:pt>
              </c:strCache>
            </c:strRef>
          </c:cat>
          <c:val>
            <c:numRef>
              <c:f>'Fig6(a)'!$J$2:$J$6</c:f>
              <c:numCache>
                <c:formatCode>General</c:formatCode>
                <c:ptCount val="5"/>
                <c:pt idx="0">
                  <c:v>74.473684210526301</c:v>
                </c:pt>
                <c:pt idx="1">
                  <c:v>63.771929824561404</c:v>
                </c:pt>
                <c:pt idx="2">
                  <c:v>61.929824561403507</c:v>
                </c:pt>
                <c:pt idx="3">
                  <c:v>62.01754385964913</c:v>
                </c:pt>
                <c:pt idx="4">
                  <c:v>72.5438596491227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615-493B-97E0-56C452BE299E}"/>
            </c:ext>
          </c:extLst>
        </c:ser>
        <c:ser>
          <c:idx val="1"/>
          <c:order val="1"/>
          <c:tx>
            <c:strRef>
              <c:f>'Fig6(a)'!$K$1</c:f>
              <c:strCache>
                <c:ptCount val="1"/>
                <c:pt idx="0">
                  <c:v>maSigPro+OPM</c:v>
                </c:pt>
              </c:strCache>
            </c:strRef>
          </c:tx>
          <c:spPr>
            <a:solidFill>
              <a:schemeClr val="accent4"/>
            </a:solidFill>
            <a:ln w="317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6(a)'!$O$2:$O$6</c:f>
                <c:numCache>
                  <c:formatCode>General</c:formatCode>
                  <c:ptCount val="5"/>
                  <c:pt idx="0">
                    <c:v>15</c:v>
                  </c:pt>
                  <c:pt idx="1">
                    <c:v>8.1578947368421382</c:v>
                  </c:pt>
                  <c:pt idx="2">
                    <c:v>1.3157894736842053</c:v>
                  </c:pt>
                  <c:pt idx="3">
                    <c:v>1.3157894736842053</c:v>
                  </c:pt>
                  <c:pt idx="4">
                    <c:v>8.1578947368421382</c:v>
                  </c:pt>
                </c:numCache>
              </c:numRef>
            </c:plus>
            <c:minus>
              <c:numRef>
                <c:f>'Fig6(a)'!$S$2:$S$6</c:f>
                <c:numCache>
                  <c:formatCode>General</c:formatCode>
                  <c:ptCount val="5"/>
                  <c:pt idx="0">
                    <c:v>19.473684210526301</c:v>
                  </c:pt>
                  <c:pt idx="1">
                    <c:v>11.052631578947356</c:v>
                  </c:pt>
                  <c:pt idx="2">
                    <c:v>2.6315789473683964</c:v>
                  </c:pt>
                  <c:pt idx="3">
                    <c:v>2.6315789473683964</c:v>
                  </c:pt>
                  <c:pt idx="4">
                    <c:v>11.052631578947356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6(a)'!$I$2:$I$6</c:f>
              <c:strCache>
                <c:ptCount val="5"/>
                <c:pt idx="0">
                  <c:v>CP1</c:v>
                </c:pt>
                <c:pt idx="1">
                  <c:v>CP2</c:v>
                </c:pt>
                <c:pt idx="2">
                  <c:v>CP3</c:v>
                </c:pt>
                <c:pt idx="3">
                  <c:v>CP4</c:v>
                </c:pt>
                <c:pt idx="4">
                  <c:v>CP5</c:v>
                </c:pt>
              </c:strCache>
            </c:strRef>
          </c:cat>
          <c:val>
            <c:numRef>
              <c:f>'Fig6(a)'!$K$2:$K$6</c:f>
              <c:numCache>
                <c:formatCode>General</c:formatCode>
                <c:ptCount val="5"/>
                <c:pt idx="0">
                  <c:v>74.473684210526301</c:v>
                </c:pt>
                <c:pt idx="1">
                  <c:v>76.052631578947356</c:v>
                </c:pt>
                <c:pt idx="2">
                  <c:v>77.631578947368396</c:v>
                </c:pt>
                <c:pt idx="3">
                  <c:v>77.631578947368396</c:v>
                </c:pt>
                <c:pt idx="4">
                  <c:v>76.0526315789473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615-493B-97E0-56C452BE29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5596639"/>
        <c:axId val="662231919"/>
      </c:barChart>
      <c:catAx>
        <c:axId val="665596639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2231919"/>
        <c:crosses val="autoZero"/>
        <c:auto val="1"/>
        <c:lblAlgn val="ctr"/>
        <c:lblOffset val="100"/>
        <c:noMultiLvlLbl val="0"/>
      </c:catAx>
      <c:valAx>
        <c:axId val="66223191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2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2000" dirty="0">
                    <a:solidFill>
                      <a:schemeClr val="tx1"/>
                    </a:solidFill>
                  </a:rPr>
                  <a:t>Accuracy (%)</a:t>
                </a:r>
                <a:endParaRPr lang="ja-JP" sz="20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2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5596639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8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6(b)(2)'!$J$1</c:f>
              <c:strCache>
                <c:ptCount val="1"/>
                <c:pt idx="0">
                  <c:v>maSigPro+MLR</c:v>
                </c:pt>
              </c:strCache>
            </c:strRef>
          </c:tx>
          <c:spPr>
            <a:solidFill>
              <a:schemeClr val="bg1"/>
            </a:solidFill>
            <a:ln w="317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6(b)(2)'!$N$2:$N$5</c:f>
                <c:numCache>
                  <c:formatCode>General</c:formatCode>
                  <c:ptCount val="4"/>
                  <c:pt idx="0">
                    <c:v>13.425925925925924</c:v>
                  </c:pt>
                  <c:pt idx="1">
                    <c:v>6.4814814814814667</c:v>
                  </c:pt>
                  <c:pt idx="2">
                    <c:v>6.0185185185185333</c:v>
                  </c:pt>
                  <c:pt idx="3">
                    <c:v>16.666666666666671</c:v>
                  </c:pt>
                </c:numCache>
              </c:numRef>
            </c:plus>
            <c:minus>
              <c:numRef>
                <c:f>'Fig6(b)(2)'!$R$2:$R$5</c:f>
                <c:numCache>
                  <c:formatCode>General</c:formatCode>
                  <c:ptCount val="4"/>
                  <c:pt idx="0">
                    <c:v>12.962962962962976</c:v>
                  </c:pt>
                  <c:pt idx="1">
                    <c:v>12.962962962962933</c:v>
                  </c:pt>
                  <c:pt idx="2">
                    <c:v>9.2592592592592666</c:v>
                  </c:pt>
                  <c:pt idx="3">
                    <c:v>8.3333333333333286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6(b)(2)'!$I$2:$I$5</c:f>
              <c:strCache>
                <c:ptCount val="4"/>
                <c:pt idx="0">
                  <c:v>CP1</c:v>
                </c:pt>
                <c:pt idx="1">
                  <c:v>CP2</c:v>
                </c:pt>
                <c:pt idx="2">
                  <c:v>CP3</c:v>
                </c:pt>
                <c:pt idx="3">
                  <c:v>CP4</c:v>
                </c:pt>
              </c:strCache>
            </c:strRef>
          </c:cat>
          <c:val>
            <c:numRef>
              <c:f>'Fig6(b)(2)'!$J$2:$J$5</c:f>
              <c:numCache>
                <c:formatCode>General</c:formatCode>
                <c:ptCount val="4"/>
                <c:pt idx="0">
                  <c:v>75.462962962962976</c:v>
                </c:pt>
                <c:pt idx="1">
                  <c:v>68.518518518518533</c:v>
                </c:pt>
                <c:pt idx="2">
                  <c:v>71.759259259259267</c:v>
                </c:pt>
                <c:pt idx="3">
                  <c:v>8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F2-41AD-A77D-2BAB59AB48CB}"/>
            </c:ext>
          </c:extLst>
        </c:ser>
        <c:ser>
          <c:idx val="1"/>
          <c:order val="1"/>
          <c:tx>
            <c:strRef>
              <c:f>'Fig6(b)(2)'!$K$1</c:f>
              <c:strCache>
                <c:ptCount val="1"/>
                <c:pt idx="0">
                  <c:v>OLM+MLR</c:v>
                </c:pt>
              </c:strCache>
            </c:strRef>
          </c:tx>
          <c:spPr>
            <a:solidFill>
              <a:schemeClr val="accent4"/>
            </a:solidFill>
            <a:ln w="381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ig6(b)(2)'!$O$2:$O$5</c:f>
                <c:numCache>
                  <c:formatCode>General</c:formatCode>
                  <c:ptCount val="4"/>
                  <c:pt idx="0">
                    <c:v>13.425925925925924</c:v>
                  </c:pt>
                  <c:pt idx="1">
                    <c:v>9.2592592592592666</c:v>
                  </c:pt>
                  <c:pt idx="2">
                    <c:v>13.425925925925924</c:v>
                  </c:pt>
                  <c:pt idx="3">
                    <c:v>9.2592592592592666</c:v>
                  </c:pt>
                </c:numCache>
              </c:numRef>
            </c:plus>
            <c:minus>
              <c:numRef>
                <c:f>'Fig6(b)(2)'!$S$2:$S$5</c:f>
                <c:numCache>
                  <c:formatCode>General</c:formatCode>
                  <c:ptCount val="4"/>
                  <c:pt idx="0">
                    <c:v>12.962962962962976</c:v>
                  </c:pt>
                  <c:pt idx="1">
                    <c:v>4.6296296296296333</c:v>
                  </c:pt>
                  <c:pt idx="2">
                    <c:v>12.962962962962976</c:v>
                  </c:pt>
                  <c:pt idx="3">
                    <c:v>4.6296296296296333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6(b)(2)'!$I$2:$I$5</c:f>
              <c:strCache>
                <c:ptCount val="4"/>
                <c:pt idx="0">
                  <c:v>CP1</c:v>
                </c:pt>
                <c:pt idx="1">
                  <c:v>CP2</c:v>
                </c:pt>
                <c:pt idx="2">
                  <c:v>CP3</c:v>
                </c:pt>
                <c:pt idx="3">
                  <c:v>CP4</c:v>
                </c:pt>
              </c:strCache>
            </c:strRef>
          </c:cat>
          <c:val>
            <c:numRef>
              <c:f>'Fig6(b)(2)'!$K$2:$K$5</c:f>
              <c:numCache>
                <c:formatCode>General</c:formatCode>
                <c:ptCount val="4"/>
                <c:pt idx="0">
                  <c:v>75.462962962962976</c:v>
                </c:pt>
                <c:pt idx="1">
                  <c:v>79.629629629629633</c:v>
                </c:pt>
                <c:pt idx="2">
                  <c:v>75.462962962962976</c:v>
                </c:pt>
                <c:pt idx="3">
                  <c:v>79.6296296296296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FF2-41AD-A77D-2BAB59AB48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5596639"/>
        <c:axId val="662231919"/>
      </c:barChart>
      <c:catAx>
        <c:axId val="665596639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2231919"/>
        <c:crosses val="autoZero"/>
        <c:auto val="1"/>
        <c:lblAlgn val="ctr"/>
        <c:lblOffset val="100"/>
        <c:noMultiLvlLbl val="0"/>
      </c:catAx>
      <c:valAx>
        <c:axId val="662231919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2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2000" dirty="0">
                    <a:solidFill>
                      <a:schemeClr val="tx1"/>
                    </a:solidFill>
                  </a:rPr>
                  <a:t>Accuracy (%)</a:t>
                </a:r>
                <a:endParaRPr lang="ja-JP" sz="20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2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5596639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8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419306-20D3-40DE-B5F4-A464E2359F3B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FC2D5B-CBA7-414F-863A-913C7F3A73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113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FC2D5B-CBA7-414F-863A-913C7F3A735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0013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0BDBBA-A374-4F8C-94CD-977165F699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7E295F6-AFEB-458C-9807-B94E209141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88827DD-234D-4CF8-B04F-8116F177F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BB26BE-BFD8-4844-9A31-FB4D9B9C1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CD97E73-DF81-4355-9B49-BE2D97794C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5438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B14BAE-D85A-419E-9703-E5CC3FE50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B5C4533-E8C4-40F7-86A8-75DEB28138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6204BB-D0F9-4E1C-8E44-587CC632B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34EFD5-98C7-45D7-A342-E4E699AA4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E576C0C-658E-47F4-8A05-984C89180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4702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E44572B-5BE6-4704-8973-5D24875283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E88B2E4-62BE-4D72-9082-9DDF8AD8F0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8CB8AC-29A9-4DF3-8A76-081852D7A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F32DA62-D1D4-4F6A-9AC2-19CD01807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FA7FA6-F698-44CC-A896-FA9A8798E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766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8C6849-7E37-47B3-B153-BBCF0FC8A2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C7A8CE8-D064-411E-8E84-DBA01ABEBA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2122D20-6F7C-4865-B61A-DCC9E1E3A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B79924-4281-4CBC-8633-D8323A2F3E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9F861E-D3C6-4E0A-9765-5C9B4983C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771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57A5A1-17D2-4151-98A5-CDF32051DC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D7E61E-E961-47E7-919F-CF8F7F869B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C4886E-05E9-4FF7-94F4-A973C232C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61F824F-773A-4C80-A21C-06C18A6FC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D97672C-5383-42E2-9598-45B454AA81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195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9781AB-A242-4C97-B648-39F6AE7D19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E370834-86B7-41C7-A7F4-4B4ED9E8E3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535CA7C-F086-4DCC-A587-E643B595C9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F183614-7494-42EF-A7C4-3E20BF657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09EDAAA-4D57-4605-9E09-447944395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6EB7F3A-089A-4C58-AEEC-1475C14E4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354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BBE30F-121A-44AC-8802-1918E86F8D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EC63F3C-33F0-49A5-8244-13EB26553A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5933BDC-477A-4E47-A4D5-5FA3B8EF3C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DC0FF63-37FD-4D6C-9B02-B625091773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D466999-1F28-480A-A330-34E8736ACF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D38B0E2-7F12-4B84-8C4D-3C1BBBB151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327B70A-A08A-451B-A004-2390495CF3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F44978C-A389-4466-8D0E-AF91A79FC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8685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F1B3D2-303D-4321-B0AB-F020062D84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79923D8-4650-41EE-B278-4AF08321C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E9D3400-0AD8-472D-90D0-A92A8F926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1688202-A461-47BB-9733-31C7E2F94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7873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F01D5C4-F33C-44B7-BAE5-5C662262C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6459228-303C-4735-806D-D5E033753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D03563C-6E09-4FC2-9536-48B81F46D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814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27BAB4-28AB-44B0-AD52-A21CF3C45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4F692A3-3C26-407B-AD71-7FDEFF3411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C26B4C0-3149-4274-BFEF-3D95407AA1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32CEE11-32A0-4AAD-8136-A57875028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94688FF-0EC6-4181-809C-1E8BCBEB6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E69D96E-C3DB-4691-9350-CDBCB3781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5713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F914A8-002E-4734-B5C2-2CDC80ADE8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C5D4EA0-E080-48BB-B873-8D96AD1D8A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B6D42E7-7F36-443B-9CD4-6799718D75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2A62E16-ECB0-43F5-BEAC-72DFD5CB2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7822C68-E518-4A65-87F6-C568AC9E9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01119F2-325F-4EEB-9110-705351451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170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861332E-A420-493E-9151-DE3F89AB5B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E88E04-D14D-408A-AD8C-C8631FE06A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1510AD-C282-4433-A240-27CEE92D87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4C2BB-7628-43F0-B905-F4BAF94298DE}" type="datetimeFigureOut">
              <a:rPr kumimoji="1" lang="ja-JP" altLang="en-US" smtClean="0"/>
              <a:t>2021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A959C5-90F0-4D55-8EFA-48DFDA0B19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6D0D59-8C71-4A7F-8670-817CA3F2B2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ACA43-E510-4CF9-B195-FF746A6CB7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7610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617FCF5-F693-490E-BC8D-8F44E1214658}"/>
              </a:ext>
            </a:extLst>
          </p:cNvPr>
          <p:cNvSpPr txBox="1"/>
          <p:nvPr/>
        </p:nvSpPr>
        <p:spPr>
          <a:xfrm>
            <a:off x="114299" y="1082632"/>
            <a:ext cx="25895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120D8D9-8F43-43EC-98AA-74A35E495249}"/>
              </a:ext>
            </a:extLst>
          </p:cNvPr>
          <p:cNvSpPr txBox="1"/>
          <p:nvPr/>
        </p:nvSpPr>
        <p:spPr>
          <a:xfrm>
            <a:off x="6069624" y="1064180"/>
            <a:ext cx="25895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B7E3044-085D-458A-B4F2-61B343705BEA}"/>
              </a:ext>
            </a:extLst>
          </p:cNvPr>
          <p:cNvGrpSpPr/>
          <p:nvPr/>
        </p:nvGrpSpPr>
        <p:grpSpPr>
          <a:xfrm>
            <a:off x="3891356" y="5984525"/>
            <a:ext cx="5690794" cy="486561"/>
            <a:chOff x="2586431" y="5876926"/>
            <a:chExt cx="5690794" cy="486561"/>
          </a:xfrm>
        </p:grpSpPr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5E04CB4B-55C3-4800-9878-F36EDACD69EA}"/>
                </a:ext>
              </a:extLst>
            </p:cNvPr>
            <p:cNvSpPr/>
            <p:nvPr/>
          </p:nvSpPr>
          <p:spPr>
            <a:xfrm>
              <a:off x="2586431" y="5876926"/>
              <a:ext cx="5690794" cy="48656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ja-JP" altLang="en-U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en-US" altLang="ja-JP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LR+maSigPro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:</a:t>
              </a:r>
              <a:r>
                <a:rPr kumimoji="1"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PMTPp</a:t>
              </a:r>
              <a:r>
                <a:rPr lang="en-US" altLang="ja-JP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maSigPro</a:t>
              </a:r>
              <a:r>
                <a:rPr lang="en-US" altLang="ja-JP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kumimoji="1" lang="ja-JP" alt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0DB8B3E0-9AA1-431C-9E69-98AFB3E89F6F}"/>
                </a:ext>
              </a:extLst>
            </p:cNvPr>
            <p:cNvSpPr/>
            <p:nvPr/>
          </p:nvSpPr>
          <p:spPr>
            <a:xfrm>
              <a:off x="2748677" y="5975806"/>
              <a:ext cx="252000" cy="252000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28610228-B33A-446C-8677-99428D240F86}"/>
                </a:ext>
              </a:extLst>
            </p:cNvPr>
            <p:cNvSpPr/>
            <p:nvPr/>
          </p:nvSpPr>
          <p:spPr>
            <a:xfrm>
              <a:off x="5415241" y="5975806"/>
              <a:ext cx="252000" cy="252000"/>
            </a:xfrm>
            <a:prstGeom prst="rect">
              <a:avLst/>
            </a:prstGeom>
            <a:solidFill>
              <a:schemeClr val="accent4"/>
            </a:solidFill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7E2DFAE4-44D1-4EEE-BAF0-DE7CCCC2E7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4183732"/>
              </p:ext>
            </p:extLst>
          </p:nvPr>
        </p:nvGraphicFramePr>
        <p:xfrm>
          <a:off x="212035" y="1434526"/>
          <a:ext cx="6094800" cy="4442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323B76B4-46FB-4A47-9FDB-688E658C08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0822017"/>
              </p:ext>
            </p:extLst>
          </p:nvPr>
        </p:nvGraphicFramePr>
        <p:xfrm>
          <a:off x="6306835" y="1434526"/>
          <a:ext cx="5238000" cy="4442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4235602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40</TotalTime>
  <Words>16</Words>
  <Application>Microsoft Office PowerPoint</Application>
  <PresentationFormat>ワイド画面</PresentationFormat>
  <Paragraphs>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riKA</dc:creator>
  <cp:lastModifiedBy>福島 亜梨花</cp:lastModifiedBy>
  <cp:revision>206</cp:revision>
  <dcterms:created xsi:type="dcterms:W3CDTF">2019-03-17T13:39:24Z</dcterms:created>
  <dcterms:modified xsi:type="dcterms:W3CDTF">2021-01-18T15:13:17Z</dcterms:modified>
</cp:coreProperties>
</file>